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4" d="100"/>
          <a:sy n="74" d="100"/>
        </p:scale>
        <p:origin x="376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21974E-4A66-FF9E-5D0C-6648DB1A465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CCE2B87-8C8F-CC37-428F-F53EFE42F9F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0E0FD8-0353-85E6-8367-B7CC57AF24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CFA593-C365-48EB-993D-BAEA5ED018DA}" type="datetimeFigureOut">
              <a:rPr lang="en-US" smtClean="0"/>
              <a:t>10/1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7EBBF6-97B9-9AF1-EE0C-0AB768673D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4FEFA47-3CF2-72D6-8D50-1544B5E4FE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144798-A807-4236-AC29-6BF7948EF9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59409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8884CC-D1C5-4B64-9BA2-62BDD1966F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E62C9D1-F28C-DF80-9112-D930A6836F6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7F7429-3CF3-01C2-8AA4-BEFC4282F4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CFA593-C365-48EB-993D-BAEA5ED018DA}" type="datetimeFigureOut">
              <a:rPr lang="en-US" smtClean="0"/>
              <a:t>10/1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6ED6A3-86CF-49DC-9279-52A70920DF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28AF2BF-EBE4-1FF1-BC79-57C8EE8C5B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144798-A807-4236-AC29-6BF7948EF9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92961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68C3084-5251-76E6-E40E-7539199E52B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99E36AF-ECCA-4A0C-8DAF-267368973DE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F0FA6C1-6B03-7B38-15E6-793A7A13D8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CFA593-C365-48EB-993D-BAEA5ED018DA}" type="datetimeFigureOut">
              <a:rPr lang="en-US" smtClean="0"/>
              <a:t>10/1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2C9710-D1C2-66CB-F32A-CCC2CEEA8F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269380-A539-2131-D554-0BC7E02914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144798-A807-4236-AC29-6BF7948EF9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89140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E694FE-1168-E25D-A2C8-7B7A7A8CBE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04F7D75-CE2D-2B8D-CD9A-424989402BA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4C6A75F-E27D-D812-40AC-C688B4B7FC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CFA593-C365-48EB-993D-BAEA5ED018DA}" type="datetimeFigureOut">
              <a:rPr lang="en-US" smtClean="0"/>
              <a:t>10/1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4EF2A8-34A7-59E6-BCEA-4D45F07BC6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F291DD-6EE9-77CA-6CFF-6929829B3D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144798-A807-4236-AC29-6BF7948EF9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57551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AF9C09-B4A3-5E3E-8952-BEE38F89F3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01DB806-DD0C-AA07-CF60-393B9D0E4BC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92E6192-21BE-837F-AA28-AD6C47ABFE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CFA593-C365-48EB-993D-BAEA5ED018DA}" type="datetimeFigureOut">
              <a:rPr lang="en-US" smtClean="0"/>
              <a:t>10/1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D811DCB-5C6C-9596-4A18-9B45E64F99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81DCD8D-E606-CD39-693B-9E0A8188CE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144798-A807-4236-AC29-6BF7948EF9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81631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221FB9-452B-8A5A-8668-F4FA7AAACA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E26D141-92AE-FD43-EE6D-CF77DE9F65A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A2B917D-1FB2-A6FB-6ABB-A713496091E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2C3DCC0-ECB5-F32C-B4E8-9E3BF67926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CFA593-C365-48EB-993D-BAEA5ED018DA}" type="datetimeFigureOut">
              <a:rPr lang="en-US" smtClean="0"/>
              <a:t>10/1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84702AC-9001-7172-7242-CF376748EB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68F4C0A-07AF-A853-3358-CF1B7FFDFB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144798-A807-4236-AC29-6BF7948EF9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58280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8B2122-2E6C-79E9-3E4B-8F6135E77D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46549DA-4F3B-5512-90C8-D01F885E72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741D8D2-FA8F-DCA9-3B04-7FD7017743F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3073D01-B65B-C230-D61F-D7A0737CFB4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8BEB8D9-3609-2B77-F037-892E3517DD2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C05F7C4-49B9-C83A-0EBF-9168338C08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CFA593-C365-48EB-993D-BAEA5ED018DA}" type="datetimeFigureOut">
              <a:rPr lang="en-US" smtClean="0"/>
              <a:t>10/13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74739A1-3EF3-AFFC-C784-136FB61E27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5F32837-37DE-BCD3-A14F-7F184165C6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144798-A807-4236-AC29-6BF7948EF9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74066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EC871E-5C80-166A-2A50-7F36A8566E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58CD188-8760-186E-F1ED-CCCAF535F8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CFA593-C365-48EB-993D-BAEA5ED018DA}" type="datetimeFigureOut">
              <a:rPr lang="en-US" smtClean="0"/>
              <a:t>10/13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3E91461-7877-2482-1D72-6F060C9031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4A0A60C-FB76-88E2-B4BE-3982F893F4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144798-A807-4236-AC29-6BF7948EF9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60169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7F6D93F-758B-3DA3-012E-DB732C5C7B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CFA593-C365-48EB-993D-BAEA5ED018DA}" type="datetimeFigureOut">
              <a:rPr lang="en-US" smtClean="0"/>
              <a:t>10/13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6D406CB-7BDA-2AE5-3A23-B34AEA5D1A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6303027-267E-13BF-CC84-6303516894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144798-A807-4236-AC29-6BF7948EF9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82546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58BC1D-F713-04DD-2A20-47D41FE1DC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BD94B38-1554-FFFC-4EDD-206C97960F5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98AEC7D-7010-8F16-78DC-25C5DA4936D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955A29B-1ED5-EE4E-38DE-880591C025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CFA593-C365-48EB-993D-BAEA5ED018DA}" type="datetimeFigureOut">
              <a:rPr lang="en-US" smtClean="0"/>
              <a:t>10/1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084BB39-4CB6-CA57-D649-03AC88D654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A34C69B-3438-B3C9-E39A-3B0D9ACD00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144798-A807-4236-AC29-6BF7948EF9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48505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4FBE87-9CCA-D83A-32B2-CD12F1AB32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636C909-B130-B14F-A3DF-8A508279FBC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4ADE4AC-BF23-D8D5-B984-EFC8B2B3449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9541BF2-756F-84BB-8478-B5F75F736C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CFA593-C365-48EB-993D-BAEA5ED018DA}" type="datetimeFigureOut">
              <a:rPr lang="en-US" smtClean="0"/>
              <a:t>10/1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14F02D0-9F79-5717-9F4C-C1ED979645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DF800A4-EFD8-3F76-6F2B-FA41D1BC4B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144798-A807-4236-AC29-6BF7948EF9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28367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D60181F-67E6-83DC-F2CD-B61FB8CAF9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1AFB02D-0B83-2E0A-6867-2A507DB5C46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6C2EEA-D2EA-8D70-FDD8-63DC622C4E2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CFA593-C365-48EB-993D-BAEA5ED018DA}" type="datetimeFigureOut">
              <a:rPr lang="en-US" smtClean="0"/>
              <a:t>10/1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BF85691-D414-97EC-DB71-7C44BDACB4E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A7B7CD4-5B47-0846-515B-28FA8BB8D7A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144798-A807-4236-AC29-6BF7948EF9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89636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>
            <a:extLst>
              <a:ext uri="{FF2B5EF4-FFF2-40B4-BE49-F238E27FC236}">
                <a16:creationId xmlns:a16="http://schemas.microsoft.com/office/drawing/2014/main" id="{511E668C-EFF0-1C6C-71AC-15659CB28E9B}"/>
              </a:ext>
            </a:extLst>
          </p:cNvPr>
          <p:cNvGrpSpPr/>
          <p:nvPr/>
        </p:nvGrpSpPr>
        <p:grpSpPr>
          <a:xfrm>
            <a:off x="668348" y="213356"/>
            <a:ext cx="10855303" cy="6506621"/>
            <a:chOff x="668348" y="213356"/>
            <a:chExt cx="10855303" cy="6506621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610DFCE9-9538-09A5-3CFF-7EB97B99174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757" t="12798" r="2591" b="2596"/>
            <a:stretch/>
          </p:blipFill>
          <p:spPr>
            <a:xfrm>
              <a:off x="668348" y="213356"/>
              <a:ext cx="10855303" cy="5763600"/>
            </a:xfrm>
            <a:prstGeom prst="rect">
              <a:avLst/>
            </a:prstGeom>
            <a:ln>
              <a:solidFill>
                <a:schemeClr val="accent1"/>
              </a:solidFill>
            </a:ln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447147A4-A741-9273-2BBC-C4986295F90F}"/>
                </a:ext>
              </a:extLst>
            </p:cNvPr>
            <p:cNvSpPr txBox="1"/>
            <p:nvPr/>
          </p:nvSpPr>
          <p:spPr>
            <a:xfrm>
              <a:off x="1035169" y="6073646"/>
              <a:ext cx="9885873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Supplementary File 3: National Coverage of Rotavirus vaccination between 2013 and 2018.</a:t>
              </a:r>
            </a:p>
            <a:p>
              <a:r>
                <a:rPr lang="en-US" dirty="0"/>
                <a:t>The blue  color shows the coverage of first dose and orange shows the coverage of the second dose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2018262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5</TotalTime>
  <Words>32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13592</dc:creator>
  <cp:lastModifiedBy>13592</cp:lastModifiedBy>
  <cp:revision>3</cp:revision>
  <dcterms:created xsi:type="dcterms:W3CDTF">2023-10-12T13:05:07Z</dcterms:created>
  <dcterms:modified xsi:type="dcterms:W3CDTF">2023-10-13T13:15:34Z</dcterms:modified>
</cp:coreProperties>
</file>